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2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0DB61-C7E7-59B2-CF4F-365B08288D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277219-11DC-56BE-3310-715EC5D9BE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50D024-A1B1-E3F6-A9E3-46C2BBF33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3E7EE4-8BC0-E0D4-BE3D-3D0275963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FF8DD8-B9C2-2507-3990-E80E1C945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059338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B4A866-C308-D40A-3C82-56668AB31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980BA0-B94E-BD20-27C6-2EEA69DE65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0E4F01-FAA5-A0C4-3271-93F487E2F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9BF902-294C-4610-20C9-B832F4EFCD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BF09D9-13F9-D659-D74A-D1239BD8D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0948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9C6643-3426-EB97-9CBB-748B92028C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CA140F-EDE6-F9BE-D0CD-9E5AC9B1B4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215EE0-2509-2B28-40F2-9BFE4C9F5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3D2B4C-F204-86B5-0AE6-17F3AA1503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5797E8-3580-252D-343B-9BF66FF13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922998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89D9B-A5E1-C81E-159F-AB0523B5C3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A25CDA-E51D-2B01-2086-BE9D7ECBE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9D0048-D53C-5237-221B-1F5526DF3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6A79F0-72DD-85EE-7B69-925E6B020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B26E8E-1752-9842-0154-2D21ACB211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374509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21DF3E-2A51-B2A3-813B-069F233A2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772A45-B847-14A3-F348-E776601C4E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B36611-AD67-6E3A-D035-16081888C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2EBD07-E990-4210-5518-3221D36BA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D65DE5-57C9-044D-6F92-3C12C8378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39424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65D05-470C-DE02-5908-1B208C3509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91C3F7-F5B4-D3D0-161F-79081C64A9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73AAE2-6A6B-E5A8-F215-5F0617E4A4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0BB000-99D3-FF70-8245-9A37E3697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DA772D-0AD8-E4A7-6CE4-DEFE97A84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1DC544-18E7-F7C2-9B32-FEE073FED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121807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FDD2F-98A4-C4A2-C166-9153605DB0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9DF0E3-8347-016F-79CB-541204BF7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D63378-5471-32F0-95F7-2261FDE16C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0AE1BD-AAE6-ADC4-BC3B-125F013CE3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7012FE-3539-BB9E-693A-A66EE44EB9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75C3E4-E350-98D9-B250-5EC8318DB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C5CA02-A80A-2D75-2445-4B96EA285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F33BCE-480A-EB95-0206-CF5FCF2FD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482002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B192C5-A543-7D28-F901-C03AE43CD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48DBDF6-9815-70A2-3060-C41966197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901792-9BA3-9A3D-28A5-909EB48A8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DE63AD-9764-28CA-CEF6-9C9F25D9F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41491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342C44-38CE-A843-FF87-1A4B7D560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1875AE-FFCD-AD16-7736-9E1C31D36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67EE61-7171-E59B-A83E-8F78B407A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9452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1E794A-0A2C-C313-3D2A-DB35855C1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0E892B-69E3-FA8F-3672-FEE751F9FD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7C69FD-910B-921C-519E-525D136296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D06979-0E77-1AE7-1CA1-96F91F20C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9AD9D6-B77C-F0AB-9CFD-9C1808F21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A983C0-FD04-7EAE-940E-14CE67C3E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30829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8CAEE8-DD41-E988-E42E-8428008992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FC594E-2610-9D67-3D3F-439C35F1BA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4D6DBB-23CB-CB7C-5905-C45C5470A0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B0C2E1-CC90-3E9F-5B66-258E2FA81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14256E-9A27-9848-22DE-DA868A730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9A1DAB-067E-B80F-A940-DE5CF9ECB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58033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60C5BC-1D33-AB74-E970-09E9C52FE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C73BF1-8A3C-CD1C-844E-F263CEFEA1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AB0F48-3DDE-9FDD-454B-BF4A1980D9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E4372-7C1B-4835-B27F-5A220ACB3E90}" type="datetimeFigureOut">
              <a:rPr lang="en-IL" smtClean="0"/>
              <a:t>01/09/2023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E460BD-38CE-2A65-648E-546354C731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86065D-2B18-13D3-2691-672A1FADEA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C734-6D20-4871-A684-EEBF03079D7E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97559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2">
            <a:extLst>
              <a:ext uri="{FF2B5EF4-FFF2-40B4-BE49-F238E27FC236}">
                <a16:creationId xmlns:a16="http://schemas.microsoft.com/office/drawing/2014/main" id="{5C1E1644-03FB-B774-25CB-12E79DB25B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4331" y="958424"/>
            <a:ext cx="9659813" cy="92333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IL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. Figure 1</a:t>
            </a:r>
            <a:r>
              <a:rPr kumimoji="0" lang="en-US" altLang="en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Phenotype analysis of CD3/CD28 stimulated TIL: Expression of co-inhibitory, co-stimulatory, and differentiation markers. An example of a gating strategy used to analyze the following surface markers: CD3, CD8, PD1, LAG3, TIM3, CD28, CD25 and CD45RA in combination with CCR7.  Cells were gated on viable and singlet T cells. </a:t>
            </a:r>
            <a:r>
              <a:rPr lang="en-US" altLang="en-IL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stained </a:t>
            </a:r>
            <a:r>
              <a:rPr lang="en-US" altLang="en-IL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, </a:t>
            </a:r>
            <a:r>
              <a:rPr lang="en-US" altLang="en-IL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out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 of any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bodies) </a:t>
            </a:r>
            <a:r>
              <a:rPr lang="en-US" altLang="en-IL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used to set the positive </a:t>
            </a:r>
            <a:r>
              <a:rPr kumimoji="0" lang="en-US" altLang="en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negative </a:t>
            </a:r>
            <a:r>
              <a:rPr kumimoji="0" lang="en-US" altLang="en-IL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actions.</a:t>
            </a:r>
            <a:endParaRPr kumimoji="0" lang="en-US" altLang="en-IL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IL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5" name="קבוצה 3">
            <a:extLst>
              <a:ext uri="{FF2B5EF4-FFF2-40B4-BE49-F238E27FC236}">
                <a16:creationId xmlns:a16="http://schemas.microsoft.com/office/drawing/2014/main" id="{1E747710-47FB-B46B-0834-497EFA3D610B}"/>
              </a:ext>
            </a:extLst>
          </p:cNvPr>
          <p:cNvGrpSpPr/>
          <p:nvPr/>
        </p:nvGrpSpPr>
        <p:grpSpPr>
          <a:xfrm>
            <a:off x="1537856" y="1881754"/>
            <a:ext cx="6803659" cy="3480896"/>
            <a:chOff x="-20613" y="-28206"/>
            <a:chExt cx="6688346" cy="272187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7AC6291-CFED-25D8-0A95-71B2F65A27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572" b="5411"/>
            <a:stretch/>
          </p:blipFill>
          <p:spPr>
            <a:xfrm>
              <a:off x="192006" y="-28206"/>
              <a:ext cx="1038747" cy="1088638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8E96BFD-A170-9A33-7A3A-5FB093B764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247" b="7242"/>
            <a:stretch/>
          </p:blipFill>
          <p:spPr>
            <a:xfrm>
              <a:off x="1563641" y="-28206"/>
              <a:ext cx="1078194" cy="106755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CE8184C-0DBB-864D-44B2-83D38BBC24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845" b="5411"/>
            <a:stretch/>
          </p:blipFill>
          <p:spPr>
            <a:xfrm>
              <a:off x="2950340" y="-28206"/>
              <a:ext cx="1047278" cy="1088638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F01DCE1-9A41-E68E-FCFD-8968CCC418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0819" b="6021"/>
            <a:stretch/>
          </p:blipFill>
          <p:spPr>
            <a:xfrm>
              <a:off x="4306123" y="-28206"/>
              <a:ext cx="1047585" cy="1081611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56FC6BC-090D-005D-7964-645A04FB60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0274" t="-1" b="4747"/>
            <a:stretch/>
          </p:blipFill>
          <p:spPr>
            <a:xfrm>
              <a:off x="1563641" y="1370704"/>
              <a:ext cx="1032665" cy="1096282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42D2DCC-723E-CE71-176C-946F11C824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2725" b="5357"/>
            <a:stretch/>
          </p:blipFill>
          <p:spPr>
            <a:xfrm>
              <a:off x="2950340" y="1370705"/>
              <a:ext cx="1004463" cy="1089254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BDE747D1-B136-E651-A791-55B63409E1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2633" b="4800"/>
            <a:stretch/>
          </p:blipFill>
          <p:spPr>
            <a:xfrm>
              <a:off x="5662214" y="-28205"/>
              <a:ext cx="1005519" cy="1095663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05849D9-675D-FC72-783E-61FABCC45B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0862" b="5357"/>
            <a:stretch/>
          </p:blipFill>
          <p:spPr>
            <a:xfrm>
              <a:off x="5641830" y="1370704"/>
              <a:ext cx="1025903" cy="1089253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9EC68099-3948-54E4-B2FC-0D6766420D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0628" b="5967"/>
            <a:stretch/>
          </p:blipFill>
          <p:spPr>
            <a:xfrm>
              <a:off x="4306123" y="1370705"/>
              <a:ext cx="1028583" cy="1082226"/>
            </a:xfrm>
            <a:prstGeom prst="rect">
              <a:avLst/>
            </a:prstGeom>
          </p:spPr>
        </p:pic>
        <p:sp>
          <p:nvSpPr>
            <p:cNvPr id="15" name="מלבן 13">
              <a:extLst>
                <a:ext uri="{FF2B5EF4-FFF2-40B4-BE49-F238E27FC236}">
                  <a16:creationId xmlns:a16="http://schemas.microsoft.com/office/drawing/2014/main" id="{5102F32E-6612-8738-BD20-883E356D11C6}"/>
                </a:ext>
              </a:extLst>
            </p:cNvPr>
            <p:cNvSpPr/>
            <p:nvPr/>
          </p:nvSpPr>
          <p:spPr>
            <a:xfrm>
              <a:off x="246057" y="1012268"/>
              <a:ext cx="941028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FSC-A 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6" name="מלבן 14">
              <a:extLst>
                <a:ext uri="{FF2B5EF4-FFF2-40B4-BE49-F238E27FC236}">
                  <a16:creationId xmlns:a16="http://schemas.microsoft.com/office/drawing/2014/main" id="{79C2B2B5-D552-5078-3B3B-61BDF80110DB}"/>
                </a:ext>
              </a:extLst>
            </p:cNvPr>
            <p:cNvSpPr/>
            <p:nvPr/>
          </p:nvSpPr>
          <p:spPr>
            <a:xfrm>
              <a:off x="4351138" y="1002902"/>
              <a:ext cx="859476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8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" name="מלבן 15">
              <a:extLst>
                <a:ext uri="{FF2B5EF4-FFF2-40B4-BE49-F238E27FC236}">
                  <a16:creationId xmlns:a16="http://schemas.microsoft.com/office/drawing/2014/main" id="{EFA2645E-D2AF-E9FB-CBE1-1AFCABF164D7}"/>
                </a:ext>
              </a:extLst>
            </p:cNvPr>
            <p:cNvSpPr/>
            <p:nvPr/>
          </p:nvSpPr>
          <p:spPr>
            <a:xfrm>
              <a:off x="3026394" y="1002903"/>
              <a:ext cx="830479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3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" name="מלבן 16">
              <a:extLst>
                <a:ext uri="{FF2B5EF4-FFF2-40B4-BE49-F238E27FC236}">
                  <a16:creationId xmlns:a16="http://schemas.microsoft.com/office/drawing/2014/main" id="{043A8A0B-69CA-8681-DA77-5F293FBE7F94}"/>
                </a:ext>
              </a:extLst>
            </p:cNvPr>
            <p:cNvSpPr/>
            <p:nvPr/>
          </p:nvSpPr>
          <p:spPr>
            <a:xfrm>
              <a:off x="5870558" y="1012270"/>
              <a:ext cx="627586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PD-1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9" name="מלבן 17">
              <a:extLst>
                <a:ext uri="{FF2B5EF4-FFF2-40B4-BE49-F238E27FC236}">
                  <a16:creationId xmlns:a16="http://schemas.microsoft.com/office/drawing/2014/main" id="{2E7E22BB-ABC0-46CC-97DE-A95B4F283C4A}"/>
                </a:ext>
              </a:extLst>
            </p:cNvPr>
            <p:cNvSpPr/>
            <p:nvPr/>
          </p:nvSpPr>
          <p:spPr>
            <a:xfrm>
              <a:off x="1627540" y="955886"/>
              <a:ext cx="898454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FSC-A 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" name="מלבן 18">
              <a:extLst>
                <a:ext uri="{FF2B5EF4-FFF2-40B4-BE49-F238E27FC236}">
                  <a16:creationId xmlns:a16="http://schemas.microsoft.com/office/drawing/2014/main" id="{3816887E-3F98-77FA-3980-8B0B0E3E68E5}"/>
                </a:ext>
              </a:extLst>
            </p:cNvPr>
            <p:cNvSpPr/>
            <p:nvPr/>
          </p:nvSpPr>
          <p:spPr>
            <a:xfrm>
              <a:off x="208442" y="2397712"/>
              <a:ext cx="894035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LAG-3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1" name="מלבן 19">
              <a:extLst>
                <a:ext uri="{FF2B5EF4-FFF2-40B4-BE49-F238E27FC236}">
                  <a16:creationId xmlns:a16="http://schemas.microsoft.com/office/drawing/2014/main" id="{663EEE3A-E712-79AD-F380-A84246B32D2A}"/>
                </a:ext>
              </a:extLst>
            </p:cNvPr>
            <p:cNvSpPr/>
            <p:nvPr/>
          </p:nvSpPr>
          <p:spPr>
            <a:xfrm>
              <a:off x="1680920" y="2426960"/>
              <a:ext cx="816872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TIM-3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2" name="מלבן 20">
              <a:extLst>
                <a:ext uri="{FF2B5EF4-FFF2-40B4-BE49-F238E27FC236}">
                  <a16:creationId xmlns:a16="http://schemas.microsoft.com/office/drawing/2014/main" id="{626D08E4-0D8C-8A52-C320-C8D8BCFA4758}"/>
                </a:ext>
              </a:extLst>
            </p:cNvPr>
            <p:cNvSpPr/>
            <p:nvPr/>
          </p:nvSpPr>
          <p:spPr>
            <a:xfrm>
              <a:off x="2997330" y="2426965"/>
              <a:ext cx="831371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25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3" name="מלבן 21">
              <a:extLst>
                <a:ext uri="{FF2B5EF4-FFF2-40B4-BE49-F238E27FC236}">
                  <a16:creationId xmlns:a16="http://schemas.microsoft.com/office/drawing/2014/main" id="{8DB92292-816E-5C13-912F-AE69481C3825}"/>
                </a:ext>
              </a:extLst>
            </p:cNvPr>
            <p:cNvSpPr/>
            <p:nvPr/>
          </p:nvSpPr>
          <p:spPr>
            <a:xfrm>
              <a:off x="4644228" y="2408318"/>
              <a:ext cx="641592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28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4" name="מלבן 22">
              <a:extLst>
                <a:ext uri="{FF2B5EF4-FFF2-40B4-BE49-F238E27FC236}">
                  <a16:creationId xmlns:a16="http://schemas.microsoft.com/office/drawing/2014/main" id="{934E0C43-34A2-1C2B-7F5D-7F39EB691C93}"/>
                </a:ext>
              </a:extLst>
            </p:cNvPr>
            <p:cNvSpPr/>
            <p:nvPr/>
          </p:nvSpPr>
          <p:spPr>
            <a:xfrm>
              <a:off x="5870558" y="2408476"/>
              <a:ext cx="793115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45RA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5" name="מלבן 23">
              <a:extLst>
                <a:ext uri="{FF2B5EF4-FFF2-40B4-BE49-F238E27FC236}">
                  <a16:creationId xmlns:a16="http://schemas.microsoft.com/office/drawing/2014/main" id="{04017824-C6C0-CCD4-2A22-C116093ABB5A}"/>
                </a:ext>
              </a:extLst>
            </p:cNvPr>
            <p:cNvSpPr/>
            <p:nvPr/>
          </p:nvSpPr>
          <p:spPr>
            <a:xfrm rot="16200000">
              <a:off x="1043560" y="503359"/>
              <a:ext cx="1066544" cy="266701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FSC-H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6" name="מלבן 24">
              <a:extLst>
                <a:ext uri="{FF2B5EF4-FFF2-40B4-BE49-F238E27FC236}">
                  <a16:creationId xmlns:a16="http://schemas.microsoft.com/office/drawing/2014/main" id="{86965D78-0FCD-CE6D-A5A6-1CBCE61CA0E4}"/>
                </a:ext>
              </a:extLst>
            </p:cNvPr>
            <p:cNvSpPr/>
            <p:nvPr/>
          </p:nvSpPr>
          <p:spPr>
            <a:xfrm rot="16200000">
              <a:off x="5303954" y="1772949"/>
              <a:ext cx="598170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CR7</a:t>
              </a:r>
              <a:endParaRPr lang="en-I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7" name="מלבן 25">
              <a:extLst>
                <a:ext uri="{FF2B5EF4-FFF2-40B4-BE49-F238E27FC236}">
                  <a16:creationId xmlns:a16="http://schemas.microsoft.com/office/drawing/2014/main" id="{020A5114-17CA-1584-9412-D5DCCD5C53A5}"/>
                </a:ext>
              </a:extLst>
            </p:cNvPr>
            <p:cNvSpPr/>
            <p:nvPr/>
          </p:nvSpPr>
          <p:spPr>
            <a:xfrm rot="16200000">
              <a:off x="2440198" y="473646"/>
              <a:ext cx="868105" cy="266701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SSC-A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8" name="מלבן 26">
              <a:extLst>
                <a:ext uri="{FF2B5EF4-FFF2-40B4-BE49-F238E27FC236}">
                  <a16:creationId xmlns:a16="http://schemas.microsoft.com/office/drawing/2014/main" id="{1BCF6D81-7D8B-9126-566A-1A9EB7954C9C}"/>
                </a:ext>
              </a:extLst>
            </p:cNvPr>
            <p:cNvSpPr/>
            <p:nvPr/>
          </p:nvSpPr>
          <p:spPr>
            <a:xfrm rot="16200000">
              <a:off x="5334749" y="317010"/>
              <a:ext cx="554782" cy="266701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8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9" name="מלבן 27">
              <a:extLst>
                <a:ext uri="{FF2B5EF4-FFF2-40B4-BE49-F238E27FC236}">
                  <a16:creationId xmlns:a16="http://schemas.microsoft.com/office/drawing/2014/main" id="{9D5B13BA-3A5D-9F05-6C14-1E958266F2FD}"/>
                </a:ext>
              </a:extLst>
            </p:cNvPr>
            <p:cNvSpPr/>
            <p:nvPr/>
          </p:nvSpPr>
          <p:spPr>
            <a:xfrm rot="16200000">
              <a:off x="3959644" y="1779975"/>
              <a:ext cx="488315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8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0" name="מלבן 28">
              <a:extLst>
                <a:ext uri="{FF2B5EF4-FFF2-40B4-BE49-F238E27FC236}">
                  <a16:creationId xmlns:a16="http://schemas.microsoft.com/office/drawing/2014/main" id="{1A84E677-3E11-47EF-0AB3-94DF232FCA3A}"/>
                </a:ext>
              </a:extLst>
            </p:cNvPr>
            <p:cNvSpPr/>
            <p:nvPr/>
          </p:nvSpPr>
          <p:spPr>
            <a:xfrm rot="16200000">
              <a:off x="2391265" y="1909639"/>
              <a:ext cx="945476" cy="266701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8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1" name="מלבן 29">
              <a:extLst>
                <a:ext uri="{FF2B5EF4-FFF2-40B4-BE49-F238E27FC236}">
                  <a16:creationId xmlns:a16="http://schemas.microsoft.com/office/drawing/2014/main" id="{4ACF2333-D369-DA91-AC46-2C304363D25D}"/>
                </a:ext>
              </a:extLst>
            </p:cNvPr>
            <p:cNvSpPr/>
            <p:nvPr/>
          </p:nvSpPr>
          <p:spPr>
            <a:xfrm rot="16200000">
              <a:off x="1039823" y="1847138"/>
              <a:ext cx="944584" cy="266701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8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2" name="מלבן 30">
              <a:extLst>
                <a:ext uri="{FF2B5EF4-FFF2-40B4-BE49-F238E27FC236}">
                  <a16:creationId xmlns:a16="http://schemas.microsoft.com/office/drawing/2014/main" id="{A0C22B64-0598-CEB5-80F9-9C9C637DE33B}"/>
                </a:ext>
              </a:extLst>
            </p:cNvPr>
            <p:cNvSpPr/>
            <p:nvPr/>
          </p:nvSpPr>
          <p:spPr>
            <a:xfrm rot="16200000">
              <a:off x="-226788" y="361019"/>
              <a:ext cx="725453" cy="2667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SSC-A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3" name="מלבן 31">
              <a:extLst>
                <a:ext uri="{FF2B5EF4-FFF2-40B4-BE49-F238E27FC236}">
                  <a16:creationId xmlns:a16="http://schemas.microsoft.com/office/drawing/2014/main" id="{074C85FC-9117-DF42-BEAD-31F046112861}"/>
                </a:ext>
              </a:extLst>
            </p:cNvPr>
            <p:cNvSpPr/>
            <p:nvPr/>
          </p:nvSpPr>
          <p:spPr>
            <a:xfrm rot="16200000">
              <a:off x="-202302" y="1709132"/>
              <a:ext cx="630079" cy="266701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D8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F5203B8C-0CF2-8754-94C4-DBC35304BE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9692" b="5357"/>
            <a:stretch/>
          </p:blipFill>
          <p:spPr>
            <a:xfrm>
              <a:off x="192006" y="1370704"/>
              <a:ext cx="1039366" cy="1089254"/>
            </a:xfrm>
            <a:prstGeom prst="rect">
              <a:avLst/>
            </a:prstGeom>
          </p:spPr>
        </p:pic>
        <p:sp>
          <p:nvSpPr>
            <p:cNvPr id="35" name="מלבן 32">
              <a:extLst>
                <a:ext uri="{FF2B5EF4-FFF2-40B4-BE49-F238E27FC236}">
                  <a16:creationId xmlns:a16="http://schemas.microsoft.com/office/drawing/2014/main" id="{1A13C497-A2A2-C6F1-3AC0-DF5624AA9931}"/>
                </a:ext>
              </a:extLst>
            </p:cNvPr>
            <p:cNvSpPr/>
            <p:nvPr/>
          </p:nvSpPr>
          <p:spPr>
            <a:xfrm rot="16200000">
              <a:off x="3837910" y="404230"/>
              <a:ext cx="814315" cy="351765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algn="r" rtl="1"/>
              <a:r>
                <a:rPr lang="en-US" sz="9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SSC-A</a:t>
              </a:r>
              <a:endParaRPr lang="en-IL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36" name="Rectangle 53">
            <a:extLst>
              <a:ext uri="{FF2B5EF4-FFF2-40B4-BE49-F238E27FC236}">
                <a16:creationId xmlns:a16="http://schemas.microsoft.com/office/drawing/2014/main" id="{E933B994-0243-CEC5-71EF-144D91C04B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11687175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626810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106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*************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l Besser</dc:creator>
  <cp:lastModifiedBy>Public Maabadot Melanoma 26</cp:lastModifiedBy>
  <cp:revision>9</cp:revision>
  <dcterms:created xsi:type="dcterms:W3CDTF">2022-10-31T08:07:20Z</dcterms:created>
  <dcterms:modified xsi:type="dcterms:W3CDTF">2023-01-09T09:04:01Z</dcterms:modified>
</cp:coreProperties>
</file>